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318" r:id="rId2"/>
    <p:sldId id="325" r:id="rId3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E1334AFA-A343-F64A-3573-5C16595A5835}" v="3" dt="2025-02-27T03:59:19.219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9972" autoAdjust="0"/>
    <p:restoredTop sz="94660"/>
  </p:normalViewPr>
  <p:slideViewPr>
    <p:cSldViewPr snapToGrid="0">
      <p:cViewPr varScale="1">
        <p:scale>
          <a:sx n="112" d="100"/>
          <a:sy n="112" d="100"/>
        </p:scale>
        <p:origin x="264" y="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microsoft.com/office/2015/10/relationships/revisionInfo" Target="revisionInfo.xml"/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6CE7D5-CF57-46EF-B807-FDD0502418D4}" type="datetimeFigureOut">
              <a:rPr lang="en-US" smtClean="0"/>
              <a:t>4/14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0EA680-D336-4FF7-8B7A-9848BB0A1C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8538789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6CE7D5-CF57-46EF-B807-FDD0502418D4}" type="datetimeFigureOut">
              <a:rPr lang="en-US" smtClean="0"/>
              <a:t>4/14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0EA680-D336-4FF7-8B7A-9848BB0A1C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0290545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6CE7D5-CF57-46EF-B807-FDD0502418D4}" type="datetimeFigureOut">
              <a:rPr lang="en-US" smtClean="0"/>
              <a:t>4/14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0EA680-D336-4FF7-8B7A-9848BB0A1C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7944565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6CE7D5-CF57-46EF-B807-FDD0502418D4}" type="datetimeFigureOut">
              <a:rPr lang="en-US" smtClean="0"/>
              <a:t>4/14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0EA680-D336-4FF7-8B7A-9848BB0A1C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4913845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6CE7D5-CF57-46EF-B807-FDD0502418D4}" type="datetimeFigureOut">
              <a:rPr lang="en-US" smtClean="0"/>
              <a:t>4/14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0EA680-D336-4FF7-8B7A-9848BB0A1C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9152452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6CE7D5-CF57-46EF-B807-FDD0502418D4}" type="datetimeFigureOut">
              <a:rPr lang="en-US" smtClean="0"/>
              <a:t>4/14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0EA680-D336-4FF7-8B7A-9848BB0A1C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0309203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6CE7D5-CF57-46EF-B807-FDD0502418D4}" type="datetimeFigureOut">
              <a:rPr lang="en-US" smtClean="0"/>
              <a:t>4/14/202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0EA680-D336-4FF7-8B7A-9848BB0A1C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3317233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6CE7D5-CF57-46EF-B807-FDD0502418D4}" type="datetimeFigureOut">
              <a:rPr lang="en-US" smtClean="0"/>
              <a:t>4/14/202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0EA680-D336-4FF7-8B7A-9848BB0A1C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1031255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6CE7D5-CF57-46EF-B807-FDD0502418D4}" type="datetimeFigureOut">
              <a:rPr lang="en-US" smtClean="0"/>
              <a:t>4/14/202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0EA680-D336-4FF7-8B7A-9848BB0A1C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4638898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6CE7D5-CF57-46EF-B807-FDD0502418D4}" type="datetimeFigureOut">
              <a:rPr lang="en-US" smtClean="0"/>
              <a:t>4/14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0EA680-D336-4FF7-8B7A-9848BB0A1C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7184145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6CE7D5-CF57-46EF-B807-FDD0502418D4}" type="datetimeFigureOut">
              <a:rPr lang="en-US" smtClean="0"/>
              <a:t>4/14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0EA680-D336-4FF7-8B7A-9848BB0A1C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1895827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846CE7D5-CF57-46EF-B807-FDD0502418D4}" type="datetimeFigureOut">
              <a:rPr lang="en-US" smtClean="0"/>
              <a:t>4/14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330EA680-D336-4FF7-8B7A-9848BB0A1C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6095407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.bin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2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7112EF3-C0FD-7DDB-2380-2F756A2FD441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367792" y="945091"/>
            <a:ext cx="3578352" cy="414655"/>
          </a:xfrm>
        </p:spPr>
        <p:txBody>
          <a:bodyPr>
            <a:normAutofit fontScale="92500"/>
          </a:bodyPr>
          <a:lstStyle/>
          <a:p>
            <a:pPr marL="0" indent="0">
              <a:buNone/>
            </a:pPr>
            <a:r>
              <a:rPr 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table S1: Primer sequence</a:t>
            </a:r>
          </a:p>
        </p:txBody>
      </p:sp>
      <p:graphicFrame>
        <p:nvGraphicFramePr>
          <p:cNvPr id="4" name="Table 3">
            <a:extLst>
              <a:ext uri="{FF2B5EF4-FFF2-40B4-BE49-F238E27FC236}">
                <a16:creationId xmlns:a16="http://schemas.microsoft.com/office/drawing/2014/main" id="{42261105-0123-7B7B-A636-17E3A9CF9847}"/>
              </a:ext>
            </a:extLst>
          </p:cNvPr>
          <p:cNvGraphicFramePr>
            <a:graphicFrameLocks noGrp="1"/>
          </p:cNvGraphicFramePr>
          <p:nvPr/>
        </p:nvGraphicFramePr>
        <p:xfrm>
          <a:off x="367792" y="1359746"/>
          <a:ext cx="5959856" cy="333756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884936">
                  <a:extLst>
                    <a:ext uri="{9D8B030D-6E8A-4147-A177-3AD203B41FA5}">
                      <a16:colId xmlns:a16="http://schemas.microsoft.com/office/drawing/2014/main" val="742748155"/>
                    </a:ext>
                  </a:extLst>
                </a:gridCol>
                <a:gridCol w="2441448">
                  <a:extLst>
                    <a:ext uri="{9D8B030D-6E8A-4147-A177-3AD203B41FA5}">
                      <a16:colId xmlns:a16="http://schemas.microsoft.com/office/drawing/2014/main" val="3974468750"/>
                    </a:ext>
                  </a:extLst>
                </a:gridCol>
                <a:gridCol w="2633472">
                  <a:extLst>
                    <a:ext uri="{9D8B030D-6E8A-4147-A177-3AD203B41FA5}">
                      <a16:colId xmlns:a16="http://schemas.microsoft.com/office/drawing/2014/main" val="2724988105"/>
                    </a:ext>
                  </a:extLst>
                </a:gridCol>
              </a:tblGrid>
              <a:tr h="370840">
                <a:tc>
                  <a:txBody>
                    <a:bodyPr/>
                    <a:lstStyle/>
                    <a:p>
                      <a:pPr algn="ctr"/>
                      <a:r>
                        <a:rPr lang="en-US" sz="1400" i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ene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i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orward (5’-3’)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i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everse (5’-3’)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521029133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lang="en-US" sz="1200" i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BCL6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1200" i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TGGCTTTTGTGACG GAAAT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1200" i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ACCTGAAAACCCACACTCG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4131399256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lang="en-US" sz="1200" i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STAT6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1200" i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GCAGGGAATGGTAGTGGATAG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1200" i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CAATCAGGGCCTCACCGTA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566878339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lang="en-US" sz="1200" i="1" dirty="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GAPDH</a:t>
                      </a:r>
                      <a:endParaRPr lang="en-US" sz="1200" i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1200" i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AG GCA GGG ATG </a:t>
                      </a:r>
                      <a:r>
                        <a:rPr lang="en-US" sz="1200" i="1" dirty="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TG</a:t>
                      </a:r>
                      <a:r>
                        <a:rPr lang="en-US" sz="1200" i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TTC TG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1200" i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AG CCT CAA GAT CAT CAG CA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159113409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lang="en-US" sz="1200" i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NfKB1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1200" i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CAGCACTACTTCTTGACCACC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1200" i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CTGCTCCTGAGCATTGACGTC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013217857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lang="en-US" sz="1200" i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NfKB1A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1200" i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AG TGG TCC GCC AAG TGA AG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1200" i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GATTTCTGGCTGGTTAGTGATC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285231702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lang="en-US" sz="1200" i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</a:t>
                      </a:r>
                      <a:r>
                        <a:rPr lang="el-GR" sz="1200" i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ε</a:t>
                      </a:r>
                      <a:r>
                        <a:rPr lang="en-US" sz="1200" i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LT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1200" i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GCCACACATCCACAGGC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1200" i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GGGTGAAGTCCCTGGAGC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601278824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lang="en-US" sz="1200" i="1" dirty="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IgEh</a:t>
                      </a:r>
                      <a:endParaRPr lang="en-US" sz="1200" i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1200" i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CCCTGGTCACCGTCTCCTCAG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1200" i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AGAGTCACGGAGGTGGCATT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946788718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lang="en-US" sz="1200" i="1" dirty="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IFNγ</a:t>
                      </a:r>
                      <a:endParaRPr lang="en-US" sz="1200" i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1200" i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AAGATGACCAGAGCATCCA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1200" i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TGCGTTGGACATTCAAGTC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747896609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47237787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 3">
            <a:extLst>
              <a:ext uri="{FF2B5EF4-FFF2-40B4-BE49-F238E27FC236}">
                <a16:creationId xmlns:a16="http://schemas.microsoft.com/office/drawing/2014/main" id="{A9D3CA60-BF2B-41E4-70C7-F919441E5EA7}"/>
              </a:ext>
            </a:extLst>
          </p:cNvPr>
          <p:cNvGrpSpPr/>
          <p:nvPr/>
        </p:nvGrpSpPr>
        <p:grpSpPr>
          <a:xfrm>
            <a:off x="466125" y="841044"/>
            <a:ext cx="6147230" cy="2913053"/>
            <a:chOff x="1727997" y="1133652"/>
            <a:chExt cx="6147230" cy="2913053"/>
          </a:xfrm>
        </p:grpSpPr>
        <p:pic>
          <p:nvPicPr>
            <p:cNvPr id="2" name="Picture 1">
              <a:extLst>
                <a:ext uri="{FF2B5EF4-FFF2-40B4-BE49-F238E27FC236}">
                  <a16:creationId xmlns:a16="http://schemas.microsoft.com/office/drawing/2014/main" id="{4A5151BF-FE3B-A427-B403-56272033C3CE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1727997" y="1133652"/>
              <a:ext cx="6147230" cy="2913053"/>
            </a:xfrm>
            <a:prstGeom prst="rect">
              <a:avLst/>
            </a:prstGeom>
          </p:spPr>
        </p:pic>
        <p:sp>
          <p:nvSpPr>
            <p:cNvPr id="3" name="Text Box 11">
              <a:extLst>
                <a:ext uri="{FF2B5EF4-FFF2-40B4-BE49-F238E27FC236}">
                  <a16:creationId xmlns:a16="http://schemas.microsoft.com/office/drawing/2014/main" id="{2B06DB3F-B833-37DA-D7DA-D188846CBD71}"/>
                </a:ext>
              </a:extLst>
            </p:cNvPr>
            <p:cNvSpPr txBox="1"/>
            <p:nvPr/>
          </p:nvSpPr>
          <p:spPr>
            <a:xfrm>
              <a:off x="2529803" y="1265030"/>
              <a:ext cx="1023620" cy="36830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/>
                <a:t>264nm</a:t>
              </a:r>
            </a:p>
          </p:txBody>
        </p:sp>
        <p:graphicFrame>
          <p:nvGraphicFramePr>
            <p:cNvPr id="5" name="Object 4">
              <a:extLst>
                <a:ext uri="{FF2B5EF4-FFF2-40B4-BE49-F238E27FC236}">
                  <a16:creationId xmlns:a16="http://schemas.microsoft.com/office/drawing/2014/main" id="{7A33B0D7-9715-BA41-4C9C-D76048E5441F}"/>
                </a:ext>
              </a:extLst>
            </p:cNvPr>
            <p:cNvGraphicFramePr>
              <a:graphicFrameLocks noChangeAspect="1"/>
            </p:cNvGraphicFramePr>
            <p:nvPr/>
          </p:nvGraphicFramePr>
          <p:xfrm>
            <a:off x="6096000" y="1347432"/>
            <a:ext cx="1505303" cy="852477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r:id="rId3" imgW="3015991" imgH="1707764" progId="">
                    <p:embed/>
                  </p:oleObj>
                </mc:Choice>
                <mc:Fallback>
                  <p:oleObj r:id="rId3" imgW="3015991" imgH="1707764" progId="">
                    <p:embed/>
                    <p:pic>
                      <p:nvPicPr>
                        <p:cNvPr id="5" name="Object 4">
                          <a:extLst>
                            <a:ext uri="{FF2B5EF4-FFF2-40B4-BE49-F238E27FC236}">
                              <a16:creationId xmlns:a16="http://schemas.microsoft.com/office/drawing/2014/main" id="{7A33B0D7-9715-BA41-4C9C-D76048E5441F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4"/>
                        <a:stretch>
                          <a:fillRect/>
                        </a:stretch>
                      </p:blipFill>
                      <p:spPr>
                        <a:xfrm>
                          <a:off x="6096000" y="1347432"/>
                          <a:ext cx="1505303" cy="852477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6" name="TextBox 5">
              <a:extLst>
                <a:ext uri="{FF2B5EF4-FFF2-40B4-BE49-F238E27FC236}">
                  <a16:creationId xmlns:a16="http://schemas.microsoft.com/office/drawing/2014/main" id="{C0EA5285-BAA6-1BB2-A655-8362DDEC156D}"/>
                </a:ext>
              </a:extLst>
            </p:cNvPr>
            <p:cNvSpPr txBox="1"/>
            <p:nvPr/>
          </p:nvSpPr>
          <p:spPr>
            <a:xfrm>
              <a:off x="4895036" y="1282540"/>
              <a:ext cx="1112805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Berberine</a:t>
              </a:r>
            </a:p>
          </p:txBody>
        </p:sp>
      </p:grpSp>
      <p:sp>
        <p:nvSpPr>
          <p:cNvPr id="7" name="TextBox 6">
            <a:extLst>
              <a:ext uri="{FF2B5EF4-FFF2-40B4-BE49-F238E27FC236}">
                <a16:creationId xmlns:a16="http://schemas.microsoft.com/office/drawing/2014/main" id="{293057D6-A9FA-978B-02DA-52E0F47EE47E}"/>
              </a:ext>
            </a:extLst>
          </p:cNvPr>
          <p:cNvSpPr txBox="1"/>
          <p:nvPr/>
        </p:nvSpPr>
        <p:spPr>
          <a:xfrm>
            <a:off x="347233" y="3984997"/>
            <a:ext cx="9537532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Times" panose="02020603050405020304"/>
                <a:cs typeface="Times" panose="02020603050405020304"/>
              </a:rPr>
              <a:t>Supplementary </a:t>
            </a:r>
            <a:r>
              <a:rPr lang="en-US" sz="1400" b="1">
                <a:latin typeface="Times" panose="02020603050405020304"/>
                <a:cs typeface="Times" panose="02020603050405020304"/>
              </a:rPr>
              <a:t>Figure S1</a:t>
            </a:r>
            <a:r>
              <a:rPr lang="en-US" sz="1400" b="1" dirty="0">
                <a:latin typeface="Times" panose="02020603050405020304"/>
                <a:cs typeface="Times" panose="02020603050405020304"/>
              </a:rPr>
              <a:t>. </a:t>
            </a:r>
            <a:r>
              <a:rPr lang="en-US" sz="1400" dirty="0">
                <a:latin typeface="Times" panose="02020603050405020304"/>
                <a:cs typeface="Times" panose="02020603050405020304"/>
              </a:rPr>
              <a:t>HPLC chromatogram and the chemical structure of berberine. BBR (400</a:t>
            </a:r>
            <a:r>
              <a:rPr lang="el-GR" sz="1400" dirty="0">
                <a:latin typeface="Times" panose="02020603050405020304"/>
                <a:cs typeface="Times" panose="02020603050405020304"/>
              </a:rPr>
              <a:t>μ</a:t>
            </a:r>
            <a:r>
              <a:rPr lang="en-US" sz="1400" dirty="0">
                <a:latin typeface="Times" panose="02020603050405020304"/>
                <a:cs typeface="Times" panose="02020603050405020304"/>
              </a:rPr>
              <a:t>g/mL) was analyzed on Waters 2690 HPLC system. The chromatogram was collected at wavelength of 264nm. </a:t>
            </a:r>
          </a:p>
        </p:txBody>
      </p:sp>
    </p:spTree>
    <p:extLst>
      <p:ext uri="{BB962C8B-B14F-4D97-AF65-F5344CB8AC3E}">
        <p14:creationId xmlns:p14="http://schemas.microsoft.com/office/powerpoint/2010/main" val="133771797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 Theme">
      <a:majorFont>
        <a:latin typeface="Aptos Display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ptos" panose="020B000402020202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104</Words>
  <Application>Microsoft Office PowerPoint</Application>
  <PresentationFormat>Widescreen</PresentationFormat>
  <Paragraphs>31</Paragraphs>
  <Slides>2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0</vt:i4>
      </vt:variant>
      <vt:variant>
        <vt:lpstr>Slide Titles</vt:lpstr>
      </vt:variant>
      <vt:variant>
        <vt:i4>2</vt:i4>
      </vt:variant>
    </vt:vector>
  </HeadingPairs>
  <TitlesOfParts>
    <vt:vector size="8" baseType="lpstr">
      <vt:lpstr>Aptos</vt:lpstr>
      <vt:lpstr>Aptos Display</vt:lpstr>
      <vt:lpstr>Arial</vt:lpstr>
      <vt:lpstr>Times</vt:lpstr>
      <vt:lpstr>Times New Roman</vt:lpstr>
      <vt:lpstr>office theme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/>
  <cp:lastModifiedBy>MDPI</cp:lastModifiedBy>
  <cp:revision>5</cp:revision>
  <dcterms:created xsi:type="dcterms:W3CDTF">2013-07-15T20:26:40Z</dcterms:created>
  <dcterms:modified xsi:type="dcterms:W3CDTF">2025-04-14T05:58:57Z</dcterms:modified>
</cp:coreProperties>
</file>